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42"/>
    <p:restoredTop sz="94694"/>
  </p:normalViewPr>
  <p:slideViewPr>
    <p:cSldViewPr snapToGrid="0">
      <p:cViewPr varScale="1">
        <p:scale>
          <a:sx n="84" d="100"/>
          <a:sy n="84" d="100"/>
        </p:scale>
        <p:origin x="18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9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570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01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487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134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980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0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943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13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361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83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724ED-26B3-D243-9330-19CE13892BE2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F6258-7855-324A-9BC3-532AE07DA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517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3257B9-B71D-A233-770E-8FB4A0005302}"/>
              </a:ext>
            </a:extLst>
          </p:cNvPr>
          <p:cNvSpPr txBox="1"/>
          <p:nvPr/>
        </p:nvSpPr>
        <p:spPr>
          <a:xfrm>
            <a:off x="861391" y="5233676"/>
            <a:ext cx="56360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-  Primer sequences used for cloning </a:t>
            </a:r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and RT-qPCR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769626F-17F1-D975-9645-92A90850A1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9604964"/>
              </p:ext>
            </p:extLst>
          </p:nvPr>
        </p:nvGraphicFramePr>
        <p:xfrm>
          <a:off x="143714" y="76016"/>
          <a:ext cx="6607606" cy="5138504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061670">
                  <a:extLst>
                    <a:ext uri="{9D8B030D-6E8A-4147-A177-3AD203B41FA5}">
                      <a16:colId xmlns:a16="http://schemas.microsoft.com/office/drawing/2014/main" val="3807832937"/>
                    </a:ext>
                  </a:extLst>
                </a:gridCol>
                <a:gridCol w="5545936">
                  <a:extLst>
                    <a:ext uri="{9D8B030D-6E8A-4147-A177-3AD203B41FA5}">
                      <a16:colId xmlns:a16="http://schemas.microsoft.com/office/drawing/2014/main" val="3101313615"/>
                    </a:ext>
                  </a:extLst>
                </a:gridCol>
              </a:tblGrid>
              <a:tr h="283312"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imers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5032085"/>
                  </a:ext>
                </a:extLst>
              </a:tr>
              <a:tr h="163449">
                <a:tc>
                  <a:txBody>
                    <a:bodyPr/>
                    <a:lstStyle/>
                    <a:p>
                      <a:r>
                        <a:rPr lang="en-IN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FP</a:t>
                      </a:r>
                      <a:endParaRPr lang="en-IN" sz="9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CAACCGGTCATCATGGGAATAATAGAGACTCCGAGAGG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76055656"/>
                  </a:ext>
                </a:extLst>
              </a:tr>
              <a:tr h="276592"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RP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AGCTAGCCTACTTATCGTCGTCATCCTTGTAATCACATCCTGCTCGGGTGACCTGTCCTACG’3 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8103070"/>
                  </a:ext>
                </a:extLst>
              </a:tr>
              <a:tr h="261519"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NTD RP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AGCTAGCCTACTTATCGTCGTCATCCTTGTAATCTTCTATGCGAATTCGTGGTAG 3’</a:t>
                      </a:r>
                      <a:endParaRPr lang="en-IN" sz="9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8479801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H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ATAACCGGTCATCATGGAAGGGCTAAAAATCCGCC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90119207"/>
                  </a:ext>
                </a:extLst>
              </a:tr>
              <a:tr h="261519"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H RP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ATGCTAGCCTACTTATCGTCGTCATCCTTGTAATCTGTATCGAAGGTCATTTGGTGACTGCAG 3’ </a:t>
                      </a:r>
                      <a:endParaRPr 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5566285"/>
                  </a:ext>
                </a:extLst>
              </a:tr>
              <a:tr h="163449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P F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AACCGGTTTCCAAAATAAAGCCAACGTTTG 3’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2492612"/>
                  </a:ext>
                </a:extLst>
              </a:tr>
              <a:tr h="276592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P R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AGCTAGCCTACTTATCGTCGTCATCCTTGTA ATCGGCCGGTATGATGTTGGTGGTAGGG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28602293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M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AACCGGTCATCATGAGGAGACTACCACACTCATTAGTGGC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4732837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Δ14 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ATACCGGTCATCATGCAACCAACAGACCACGTCGTG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6823156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</a:t>
                      </a: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Symbol" pitchFamily="2" charset="2"/>
                        </a:rPr>
                        <a:t></a:t>
                      </a: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TAACCGGTCATCATGTCGCCTGAAGACTTCCAGAGT 3'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5200827"/>
                  </a:ext>
                </a:extLst>
              </a:tr>
              <a:tr h="194116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</a:t>
                      </a: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Symbol" pitchFamily="2" charset="2"/>
                        </a:rPr>
                        <a:t></a:t>
                      </a: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TAACCGGTCATCATGCCAGCCCTGAACACCGACGAAGAG 3'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25526035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52A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GACGTGTTGTACGTAGCCGAGGCGTTTGCGTGCCAC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34164414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52A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GGCACGCAAACGCCTCGGCTACGTACAACACGTCGAC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50698157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192A</a:t>
                      </a:r>
                      <a:r>
                        <a:rPr lang="en-IN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GGAGTACCGGGATCTGGCGCGTCAGCTATTATCAAGAACCTAG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15112084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192A RP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TAGGTTCTTGATAATAGCTGACGCGCCAGATCCCGGTACTCC 3’</a:t>
                      </a:r>
                      <a:endParaRPr lang="en-IN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66155290"/>
                  </a:ext>
                </a:extLst>
              </a:tr>
              <a:tr h="2765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252/253AA FP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GTCGACGTGTTGTACGTAGCCGCGGCGTTTGCGTGCCAC 3’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8400880"/>
                  </a:ext>
                </a:extLst>
              </a:tr>
              <a:tr h="2765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252/253AA RP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</a:t>
                      </a: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IN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GCACGCAAACGCCGCGGCTACGTACAACACGTCGAC 3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76489629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RLE FP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GGTCTGCCACGACTGGAGGGTAGGTATG 3’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09988952"/>
                  </a:ext>
                </a:extLst>
              </a:tr>
              <a:tr h="1941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P2 RLE RP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ATACCTACCCTCCAGTCGTGGCAGACC 3’</a:t>
                      </a:r>
                      <a:endParaRPr lang="en-IN" sz="9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1464468"/>
                  </a:ext>
                </a:extLst>
              </a:tr>
              <a:tr h="1941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 RT FP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GGTGAAGGTCGGAGTCAACG 3’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18963811"/>
                  </a:ext>
                </a:extLst>
              </a:tr>
              <a:tr h="1941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 RT RP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AGGGATCTCGCTCCTGGAAG 3’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24545949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β RT FP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 TCATCCTGTCCTTGAGGCAGTAT 3’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59622150"/>
                  </a:ext>
                </a:extLst>
              </a:tr>
              <a:tr h="129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β  RT RP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9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’ CAGCAATTTTCAGTGTCAGAAGCT 3’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351554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315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159</Words>
  <Application>Microsoft Macintosh PowerPoint</Application>
  <PresentationFormat>A4 Paper (210x297 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3</cp:revision>
  <dcterms:created xsi:type="dcterms:W3CDTF">2025-07-02T11:04:23Z</dcterms:created>
  <dcterms:modified xsi:type="dcterms:W3CDTF">2025-07-30T05:51:19Z</dcterms:modified>
</cp:coreProperties>
</file>